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1" autoAdjust="0"/>
    <p:restoredTop sz="94662" autoAdjust="0"/>
  </p:normalViewPr>
  <p:slideViewPr>
    <p:cSldViewPr snapToGrid="0">
      <p:cViewPr varScale="1">
        <p:scale>
          <a:sx n="94" d="100"/>
          <a:sy n="94" d="100"/>
        </p:scale>
        <p:origin x="75" y="12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18A355-5D34-4CB4-99BD-C4DECC14A13D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9BA1CE-1F0C-480D-BBE0-5ADB8D193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49527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9BA1CE-1F0C-480D-BBE0-5ADB8D1933BC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6798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2D54F4-07A2-DD6B-F1EF-2BFC4E0CD4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7134D79-3BEC-AB59-B289-D4F5B2C753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D64622-2004-93D2-F61F-41D989504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C4EEAD-7E00-8E96-37B7-C42AD2A6D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57E06A-E3BD-46AC-62B2-DB07343A9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462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C611CB-34E5-D30A-6558-3B0267D6F3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2E159C-83F4-07A5-DA08-5ABA76E698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BC46C3-C996-C16F-1C5D-1BC7E7D40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6FF5E4-7CDC-85EF-AB23-B5400A73C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5CB793-2051-3C8A-6E2B-C6E192A51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2043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0A942E2-2FF1-738D-19FB-82D5C943EA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C614C92-7A75-AAE8-2EB0-D7A210AEFF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92312C-7BBA-3367-3898-A6AF8F525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C74A6A-6E22-0DD0-8697-9810E3D12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530324-4A3C-6FEF-F40B-5845F139B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777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6BE923-C915-8015-D34E-5DADC0BCB0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DD5DEF-873B-D429-19A0-EF85324C42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6CBD4B-0F12-17D4-3C91-74A357ED4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452C06-A064-6287-5D87-62A84160F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4F4F42-D841-D9C0-3647-E5E13813A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064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960871-49C7-DE2D-D26E-2773CC5A2D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146F58-78C1-83FC-BBD0-509648F0F7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52B267-3FC8-3BB1-36E2-67D707584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08A4E7F-5774-767A-3A62-2BE585CA6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F2E588-E7E7-FDF7-9FE9-54B8C4801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6800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C31A81-3C6A-382C-A718-E80820796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1521F4-6C32-C64F-5CB3-906FF0EC93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997C34F-7EAE-FDA5-E3EE-59EF348259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C90B67E-8EFB-0C6A-A504-E832D33C9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F6E104-F4CB-1F80-0A57-4FC45153F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D43AA7-9FD0-A4FB-21D6-A498F29C7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358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C97D8C-C2F2-6A40-F3BB-D29F165566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7EFDA63-1C2D-20FD-CBB9-7B1832D26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472FC54-6CED-BD51-DD0D-18F6DC3E98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7B522B8-D7C0-CB2E-2139-6B8A477FE8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A491DF0-52D4-5625-2EE2-9C60192A96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2E8A2CA-723D-7043-65D2-BC05C19E7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FECEE45-335E-5CCD-3F5A-752C4D58C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A00B409-39B3-9F73-C675-EA80FE0B1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857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A67549-7E76-B589-1E8C-0536D432F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0624F7A-2AB0-E19D-DF40-7EB5390E3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43FD761-EB8E-E552-733A-846A16B26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8F389F1-45BA-5268-37E9-D8F9FD008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7104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41ED6F8-45F2-4DB4-C479-9CE5786C7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4A4C87B-B072-C760-4918-7777333CF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522A9D8-2527-765B-8CA2-75D2AEBD7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5207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E9F9EC-FDB8-E10F-DF3C-04C8916A0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5ABEED-25BE-E0F5-C677-6548949BFA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E32E5BD-6399-09DE-48FB-9FA88CB128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2D65AA-4B70-BB88-B3DA-F00AA43C8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282CAEB-5257-F732-AB41-2F284C260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73B5FE-8EEB-161C-3517-872CF003D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408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F264BC-3666-3FEC-23F7-486E55056B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E2A760E-716C-544A-754F-8747CAAB78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FFDD6EC-93C8-D578-716E-2CCE060EFA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3A5B57-DADE-D70A-84FD-5A588FC5E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EC83BB-2450-F17D-C38C-CA6460C41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6CB9AD-6719-8BF7-ADC0-AD46A1908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588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7DED240-8B4B-3231-33BF-2D7DEB687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3ECA9A-8449-2BA0-0AAE-0F98FF2B88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A72F4D-F6C9-1F35-F8D5-98B341C97E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05D17F-36F0-4082-842E-A7425FA24B92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019AC8-0097-62CA-C74B-3E6C3F1C6F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73E9AF-40D7-D101-46EC-9851E098E8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DA8133-F60B-40C4-928B-D6CAB83BF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0079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g"/><Relationship Id="rId5" Type="http://schemas.openxmlformats.org/officeDocument/2006/relationships/image" Target="../media/image13.tif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C6CD343B-9436-2E26-9430-F5B2B93C84AB}"/>
              </a:ext>
            </a:extLst>
          </p:cNvPr>
          <p:cNvGrpSpPr/>
          <p:nvPr/>
        </p:nvGrpSpPr>
        <p:grpSpPr>
          <a:xfrm>
            <a:off x="1544320" y="660400"/>
            <a:ext cx="8490374" cy="5825550"/>
            <a:chOff x="1544320" y="660400"/>
            <a:chExt cx="8490374" cy="582555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A5257085-1B14-EFFE-5224-152A989907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95" b="19216"/>
            <a:stretch/>
          </p:blipFill>
          <p:spPr bwMode="auto">
            <a:xfrm>
              <a:off x="1544320" y="835024"/>
              <a:ext cx="8490374" cy="4775836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D07D62BC-A14A-4942-38B3-9110B4AFC0B2}"/>
                </a:ext>
              </a:extLst>
            </p:cNvPr>
            <p:cNvSpPr/>
            <p:nvPr/>
          </p:nvSpPr>
          <p:spPr>
            <a:xfrm>
              <a:off x="1798320" y="660400"/>
              <a:ext cx="4541520" cy="514604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E8226DA-F218-FC9B-9D7A-A3D5014505B7}"/>
                </a:ext>
              </a:extLst>
            </p:cNvPr>
            <p:cNvSpPr txBox="1"/>
            <p:nvPr/>
          </p:nvSpPr>
          <p:spPr>
            <a:xfrm>
              <a:off x="3500120" y="6085840"/>
              <a:ext cx="34772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lang="en-US" altLang="zh-CN" sz="20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e original image of Fig</a:t>
              </a:r>
              <a:r>
                <a:rPr lang="en-US" altLang="zh-CN" sz="20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.</a:t>
              </a:r>
              <a:r>
                <a:rPr lang="en-US" altLang="zh-CN" sz="20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3D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23650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>
            <a:extLst>
              <a:ext uri="{FF2B5EF4-FFF2-40B4-BE49-F238E27FC236}">
                <a16:creationId xmlns:a16="http://schemas.microsoft.com/office/drawing/2014/main" id="{68DD1BBC-8A04-F4B6-4B25-091C120405CA}"/>
              </a:ext>
            </a:extLst>
          </p:cNvPr>
          <p:cNvGrpSpPr/>
          <p:nvPr/>
        </p:nvGrpSpPr>
        <p:grpSpPr>
          <a:xfrm>
            <a:off x="1038543" y="175133"/>
            <a:ext cx="9484055" cy="6507733"/>
            <a:chOff x="1008063" y="544830"/>
            <a:chExt cx="9484055" cy="6507733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D1269CBC-8A5F-D8F9-19B9-3D28F0BD66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65" t="24899" r="28359" b="23360"/>
            <a:stretch/>
          </p:blipFill>
          <p:spPr bwMode="auto">
            <a:xfrm>
              <a:off x="1008063" y="652735"/>
              <a:ext cx="4785042" cy="348778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3D5824E0-91FA-03C1-CBE9-74684B959C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75" t="30321" r="34542" b="18595"/>
            <a:stretch/>
          </p:blipFill>
          <p:spPr bwMode="auto">
            <a:xfrm>
              <a:off x="6176009" y="544830"/>
              <a:ext cx="3966895" cy="344311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0D96B1E-025A-97BB-E944-5BAF9402FA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37" t="48536" r="19459" b="13974"/>
            <a:stretch/>
          </p:blipFill>
          <p:spPr bwMode="auto">
            <a:xfrm>
              <a:off x="5109845" y="4335080"/>
              <a:ext cx="5382273" cy="2717483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26B03316-C133-2F96-A8F1-BEAD0C57E05C}"/>
                </a:ext>
              </a:extLst>
            </p:cNvPr>
            <p:cNvSpPr/>
            <p:nvPr/>
          </p:nvSpPr>
          <p:spPr>
            <a:xfrm>
              <a:off x="2590800" y="706120"/>
              <a:ext cx="1366520" cy="2921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CE26172-770D-3693-A869-095BCF1FD4EB}"/>
                </a:ext>
              </a:extLst>
            </p:cNvPr>
            <p:cNvSpPr/>
            <p:nvPr/>
          </p:nvSpPr>
          <p:spPr>
            <a:xfrm>
              <a:off x="4043680" y="706120"/>
              <a:ext cx="1366520" cy="2921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BDD9747-A7C7-1D0A-C8CD-2EE04A9D0DD0}"/>
                </a:ext>
              </a:extLst>
            </p:cNvPr>
            <p:cNvSpPr txBox="1"/>
            <p:nvPr/>
          </p:nvSpPr>
          <p:spPr>
            <a:xfrm>
              <a:off x="2948721" y="772160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ME4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4523F27-B934-2E3D-5554-EFBF56980C8E}"/>
                </a:ext>
              </a:extLst>
            </p:cNvPr>
            <p:cNvSpPr txBox="1"/>
            <p:nvPr/>
          </p:nvSpPr>
          <p:spPr>
            <a:xfrm>
              <a:off x="4340224" y="784255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ME5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18119ED-D231-D739-9FA8-4FB6E5E0DB88}"/>
                </a:ext>
              </a:extLst>
            </p:cNvPr>
            <p:cNvSpPr/>
            <p:nvPr/>
          </p:nvSpPr>
          <p:spPr>
            <a:xfrm>
              <a:off x="8184856" y="706120"/>
              <a:ext cx="1366520" cy="2921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42FF2AE-E827-00CC-5515-D5B562E5E849}"/>
                </a:ext>
              </a:extLst>
            </p:cNvPr>
            <p:cNvSpPr txBox="1"/>
            <p:nvPr/>
          </p:nvSpPr>
          <p:spPr>
            <a:xfrm>
              <a:off x="8605520" y="831910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ME2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18C275BF-5228-6159-6EED-62EC6CC1CAA8}"/>
                </a:ext>
              </a:extLst>
            </p:cNvPr>
            <p:cNvSpPr/>
            <p:nvPr/>
          </p:nvSpPr>
          <p:spPr>
            <a:xfrm>
              <a:off x="8447405" y="4258880"/>
              <a:ext cx="1346837" cy="271748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C4135C7F-B1ED-739A-C424-03CD32345B9E}"/>
                </a:ext>
              </a:extLst>
            </p:cNvPr>
            <p:cNvSpPr/>
            <p:nvPr/>
          </p:nvSpPr>
          <p:spPr>
            <a:xfrm>
              <a:off x="5745041" y="4258878"/>
              <a:ext cx="1267043" cy="271748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56CA4FAE-F219-1F87-2B2F-1BBA2D210FCD}"/>
                </a:ext>
              </a:extLst>
            </p:cNvPr>
            <p:cNvSpPr/>
            <p:nvPr/>
          </p:nvSpPr>
          <p:spPr>
            <a:xfrm>
              <a:off x="7056119" y="4258879"/>
              <a:ext cx="1346837" cy="271748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1833E17-77E0-5C89-9775-4C06B72A04A4}"/>
                </a:ext>
              </a:extLst>
            </p:cNvPr>
            <p:cNvSpPr txBox="1"/>
            <p:nvPr/>
          </p:nvSpPr>
          <p:spPr>
            <a:xfrm>
              <a:off x="6022535" y="4403150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ME2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780C9818-A019-FBC2-B90F-5C7B05CF365B}"/>
                </a:ext>
              </a:extLst>
            </p:cNvPr>
            <p:cNvSpPr txBox="1"/>
            <p:nvPr/>
          </p:nvSpPr>
          <p:spPr>
            <a:xfrm>
              <a:off x="7373510" y="4403150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ME4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336D574-E19E-A2F2-F41B-FA1CE50F310D}"/>
                </a:ext>
              </a:extLst>
            </p:cNvPr>
            <p:cNvSpPr txBox="1"/>
            <p:nvPr/>
          </p:nvSpPr>
          <p:spPr>
            <a:xfrm>
              <a:off x="8738345" y="4403150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ME5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5DF8FE52-C122-3854-732A-26DCD94862AC}"/>
              </a:ext>
            </a:extLst>
          </p:cNvPr>
          <p:cNvSpPr txBox="1"/>
          <p:nvPr/>
        </p:nvSpPr>
        <p:spPr>
          <a:xfrm>
            <a:off x="980440" y="5324124"/>
            <a:ext cx="36760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s of Fig. 5C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5326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6FDB7AF-47D1-9237-C488-44803116625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76" t="49318" r="27710" b="16783"/>
          <a:stretch/>
        </p:blipFill>
        <p:spPr bwMode="auto">
          <a:xfrm flipH="1">
            <a:off x="918844" y="380682"/>
            <a:ext cx="3332583" cy="347703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EE509A-E227-3AD6-8C6C-BF391A61F59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720272" y="532174"/>
            <a:ext cx="5601697" cy="3417888"/>
          </a:xfrm>
          <a:prstGeom prst="rect">
            <a:avLst/>
          </a:prstGeom>
          <a:noFill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BEC3D69A-5232-1ABF-15FC-25236FA93421}"/>
              </a:ext>
            </a:extLst>
          </p:cNvPr>
          <p:cNvSpPr/>
          <p:nvPr/>
        </p:nvSpPr>
        <p:spPr>
          <a:xfrm>
            <a:off x="1731399" y="675640"/>
            <a:ext cx="1616031" cy="322362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41116B9E-44C9-A768-F974-71D0FFEE9C89}"/>
              </a:ext>
            </a:extLst>
          </p:cNvPr>
          <p:cNvSpPr/>
          <p:nvPr/>
        </p:nvSpPr>
        <p:spPr>
          <a:xfrm>
            <a:off x="8056881" y="675640"/>
            <a:ext cx="1691350" cy="322362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3200818-632F-E2B5-5B0B-C3F50E8424B8}"/>
              </a:ext>
            </a:extLst>
          </p:cNvPr>
          <p:cNvSpPr txBox="1"/>
          <p:nvPr/>
        </p:nvSpPr>
        <p:spPr>
          <a:xfrm>
            <a:off x="8473229" y="817880"/>
            <a:ext cx="12394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GST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7C7ED72-904A-D9E8-BF4A-7B1B6660658B}"/>
              </a:ext>
            </a:extLst>
          </p:cNvPr>
          <p:cNvSpPr txBox="1"/>
          <p:nvPr/>
        </p:nvSpPr>
        <p:spPr>
          <a:xfrm>
            <a:off x="1915463" y="960120"/>
            <a:ext cx="1130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HIS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3DB1E8F-8047-144D-B977-577D03D08060}"/>
              </a:ext>
            </a:extLst>
          </p:cNvPr>
          <p:cNvSpPr txBox="1"/>
          <p:nvPr/>
        </p:nvSpPr>
        <p:spPr>
          <a:xfrm>
            <a:off x="2540000" y="5643880"/>
            <a:ext cx="35333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 of Fig. 6B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83638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F62934D-E7DD-8839-059A-55D1C4104E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3239" y="617199"/>
            <a:ext cx="5170561" cy="519688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E5D42408-64B5-769C-0037-96B56548A144}"/>
              </a:ext>
            </a:extLst>
          </p:cNvPr>
          <p:cNvSpPr/>
          <p:nvPr/>
        </p:nvSpPr>
        <p:spPr>
          <a:xfrm>
            <a:off x="1391920" y="1971040"/>
            <a:ext cx="1671320" cy="10668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F9EA6B3-CE98-3EA2-7DE2-F152D3886FC5}"/>
              </a:ext>
            </a:extLst>
          </p:cNvPr>
          <p:cNvSpPr txBox="1"/>
          <p:nvPr/>
        </p:nvSpPr>
        <p:spPr>
          <a:xfrm>
            <a:off x="1288059" y="2637730"/>
            <a:ext cx="18790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GFP/Input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9A9B876-B71F-4ADF-0553-05328D939D51}"/>
              </a:ext>
            </a:extLst>
          </p:cNvPr>
          <p:cNvSpPr/>
          <p:nvPr/>
        </p:nvSpPr>
        <p:spPr>
          <a:xfrm>
            <a:off x="3235960" y="1971040"/>
            <a:ext cx="1671320" cy="11176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FA019D9-FAD2-2EE4-1BDB-480CA8C0B7C2}"/>
              </a:ext>
            </a:extLst>
          </p:cNvPr>
          <p:cNvSpPr txBox="1"/>
          <p:nvPr/>
        </p:nvSpPr>
        <p:spPr>
          <a:xfrm>
            <a:off x="3355252" y="2688530"/>
            <a:ext cx="15520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GFP/IP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CE88F5B-C534-97D1-EBE4-8E51F3BCD0BA}"/>
              </a:ext>
            </a:extLst>
          </p:cNvPr>
          <p:cNvSpPr txBox="1"/>
          <p:nvPr/>
        </p:nvSpPr>
        <p:spPr>
          <a:xfrm>
            <a:off x="3553739" y="4994850"/>
            <a:ext cx="20217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FLAG/Input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120F910-EAAF-0E23-0DAC-9A5DA782ED60}"/>
              </a:ext>
            </a:extLst>
          </p:cNvPr>
          <p:cNvSpPr txBox="1"/>
          <p:nvPr/>
        </p:nvSpPr>
        <p:spPr>
          <a:xfrm>
            <a:off x="1805425" y="4969450"/>
            <a:ext cx="16946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FLAG/IP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47326F93-D822-4EB8-3B01-5114B5E3FE9E}"/>
              </a:ext>
            </a:extLst>
          </p:cNvPr>
          <p:cNvSpPr/>
          <p:nvPr/>
        </p:nvSpPr>
        <p:spPr>
          <a:xfrm>
            <a:off x="3571240" y="4734560"/>
            <a:ext cx="1973726" cy="69596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BA38C9C2-3ADD-0B74-65E9-53C40B12513C}"/>
              </a:ext>
            </a:extLst>
          </p:cNvPr>
          <p:cNvSpPr/>
          <p:nvPr/>
        </p:nvSpPr>
        <p:spPr>
          <a:xfrm>
            <a:off x="1701800" y="4663440"/>
            <a:ext cx="1798320" cy="7315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59CC5C7-DE76-C433-FD4B-CE1EA190D6EB}"/>
              </a:ext>
            </a:extLst>
          </p:cNvPr>
          <p:cNvSpPr txBox="1"/>
          <p:nvPr/>
        </p:nvSpPr>
        <p:spPr>
          <a:xfrm>
            <a:off x="2661920" y="6056135"/>
            <a:ext cx="35477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 of Fig. 6C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66694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3B00990-0942-F2F3-85B9-5AEB6E3038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164"/>
            <a:ext cx="4598129" cy="267963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322A730-0CBC-53D6-F5BF-7C50FF6861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7572" y="153404"/>
            <a:ext cx="3935814" cy="291713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54BE7CC-F41C-E2EE-ACD0-F98BF99ED3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984" y="3234372"/>
            <a:ext cx="5369696" cy="1824653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9E74E3B-7B3B-72D9-F624-8036D660BBCC}"/>
              </a:ext>
            </a:extLst>
          </p:cNvPr>
          <p:cNvSpPr txBox="1"/>
          <p:nvPr/>
        </p:nvSpPr>
        <p:spPr>
          <a:xfrm>
            <a:off x="6558889" y="1767840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onceau S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0F7B254-623B-A04D-A33F-7F406B858A27}"/>
              </a:ext>
            </a:extLst>
          </p:cNvPr>
          <p:cNvSpPr txBox="1"/>
          <p:nvPr/>
        </p:nvSpPr>
        <p:spPr>
          <a:xfrm>
            <a:off x="1542467" y="5022806"/>
            <a:ext cx="26807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H3/Two duplicat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3A94CC0C-FDD2-3E7E-0A12-A6750102B99A}"/>
              </a:ext>
            </a:extLst>
          </p:cNvPr>
          <p:cNvSpPr/>
          <p:nvPr/>
        </p:nvSpPr>
        <p:spPr>
          <a:xfrm>
            <a:off x="518160" y="4516120"/>
            <a:ext cx="4729412" cy="4001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0E81FFA-B1B0-BE21-7630-498808EA3E5D}"/>
              </a:ext>
            </a:extLst>
          </p:cNvPr>
          <p:cNvSpPr txBox="1"/>
          <p:nvPr/>
        </p:nvSpPr>
        <p:spPr>
          <a:xfrm>
            <a:off x="1500756" y="350520"/>
            <a:ext cx="13821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FLAG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DC1EECA-C94F-726E-9C0D-3BE06725A6BE}"/>
              </a:ext>
            </a:extLst>
          </p:cNvPr>
          <p:cNvSpPr txBox="1"/>
          <p:nvPr/>
        </p:nvSpPr>
        <p:spPr>
          <a:xfrm>
            <a:off x="2661920" y="6056135"/>
            <a:ext cx="35333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 of Fig. 6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9507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357B7B3-7C06-3AFB-9EF4-50A71DD103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8551" y="436880"/>
            <a:ext cx="4567689" cy="365901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56CF284-4B4C-28B1-CA8A-B1EE6D202F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80255" y="958064"/>
            <a:ext cx="2792210" cy="54259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DC88C643-25F6-B771-1324-02E36EDC4AA7}"/>
              </a:ext>
            </a:extLst>
          </p:cNvPr>
          <p:cNvSpPr txBox="1"/>
          <p:nvPr/>
        </p:nvSpPr>
        <p:spPr>
          <a:xfrm>
            <a:off x="2894874" y="3028890"/>
            <a:ext cx="26807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H3/Two duplicat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7F4CF40A-BBCF-C04D-C7FA-01F59604900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121" r="7814" b="26960"/>
          <a:stretch/>
        </p:blipFill>
        <p:spPr>
          <a:xfrm>
            <a:off x="428070" y="4787531"/>
            <a:ext cx="5428134" cy="1314251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F3D5486E-8627-2802-F294-993ACCAF3C6C}"/>
              </a:ext>
            </a:extLst>
          </p:cNvPr>
          <p:cNvSpPr/>
          <p:nvPr/>
        </p:nvSpPr>
        <p:spPr>
          <a:xfrm>
            <a:off x="2894873" y="2687320"/>
            <a:ext cx="2177869" cy="75406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5A36E678-F55E-EA7F-F41A-678C9B20F7A0}"/>
              </a:ext>
            </a:extLst>
          </p:cNvPr>
          <p:cNvSpPr/>
          <p:nvPr/>
        </p:nvSpPr>
        <p:spPr>
          <a:xfrm>
            <a:off x="8091714" y="507977"/>
            <a:ext cx="2053772" cy="54259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AE14A01-EB0C-9D5E-9AF9-C5ADA10B3E9C}"/>
              </a:ext>
            </a:extLst>
          </p:cNvPr>
          <p:cNvSpPr txBox="1"/>
          <p:nvPr/>
        </p:nvSpPr>
        <p:spPr>
          <a:xfrm>
            <a:off x="2833577" y="5429075"/>
            <a:ext cx="2803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Rubisco/</a:t>
            </a:r>
            <a:r>
              <a:rPr lang="en-US" altLang="zh-CN" sz="2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wo duplicat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ACA5AA30-A962-2DA4-EE7F-39913EE71123}"/>
              </a:ext>
            </a:extLst>
          </p:cNvPr>
          <p:cNvSpPr/>
          <p:nvPr/>
        </p:nvSpPr>
        <p:spPr>
          <a:xfrm>
            <a:off x="3142137" y="4922211"/>
            <a:ext cx="2416135" cy="57543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63F5C8F7-1463-33C5-EE71-607E3990C0B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1433" y="4840520"/>
            <a:ext cx="5105940" cy="1314251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4623F504-E01F-F583-185A-D1E9F9A9C2B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779" y="738108"/>
            <a:ext cx="5410188" cy="3557459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44C62557-F502-55CB-5515-992C592ECEB5}"/>
              </a:ext>
            </a:extLst>
          </p:cNvPr>
          <p:cNvSpPr txBox="1"/>
          <p:nvPr/>
        </p:nvSpPr>
        <p:spPr>
          <a:xfrm>
            <a:off x="1502384" y="507738"/>
            <a:ext cx="30927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FLAG</a:t>
            </a:r>
            <a:r>
              <a:rPr kumimoji="0" lang="en-US" altLang="zh-CN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/Two duplicat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68C965C-A1A7-BD00-2FA1-B8E0D0DB1CF5}"/>
              </a:ext>
            </a:extLst>
          </p:cNvPr>
          <p:cNvSpPr txBox="1"/>
          <p:nvPr/>
        </p:nvSpPr>
        <p:spPr>
          <a:xfrm>
            <a:off x="2754881" y="3708008"/>
            <a:ext cx="2803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H3/</a:t>
            </a:r>
            <a:r>
              <a:rPr lang="en-US" altLang="zh-CN" sz="2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wo duplicat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EF50C52F-C904-CC98-63E0-7603499B4BFC}"/>
              </a:ext>
            </a:extLst>
          </p:cNvPr>
          <p:cNvSpPr/>
          <p:nvPr/>
        </p:nvSpPr>
        <p:spPr>
          <a:xfrm>
            <a:off x="1438275" y="847725"/>
            <a:ext cx="953668" cy="218116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17982B8F-DDDE-A8C6-ACE7-0F2EAC716CD6}"/>
              </a:ext>
            </a:extLst>
          </p:cNvPr>
          <p:cNvSpPr/>
          <p:nvPr/>
        </p:nvSpPr>
        <p:spPr>
          <a:xfrm>
            <a:off x="2914499" y="928679"/>
            <a:ext cx="953668" cy="218116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E46E789-CEB8-39CA-A78B-CD19D1A21CFA}"/>
              </a:ext>
            </a:extLst>
          </p:cNvPr>
          <p:cNvSpPr/>
          <p:nvPr/>
        </p:nvSpPr>
        <p:spPr>
          <a:xfrm>
            <a:off x="2754881" y="3295650"/>
            <a:ext cx="2617219" cy="4749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4BB8CE15-8982-2E4D-8D1D-7E29CD09E1DB}"/>
              </a:ext>
            </a:extLst>
          </p:cNvPr>
          <p:cNvSpPr/>
          <p:nvPr/>
        </p:nvSpPr>
        <p:spPr>
          <a:xfrm>
            <a:off x="8444403" y="4991100"/>
            <a:ext cx="2028335" cy="4379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171C104-5692-96C2-B020-8F0209AE87B6}"/>
              </a:ext>
            </a:extLst>
          </p:cNvPr>
          <p:cNvSpPr txBox="1"/>
          <p:nvPr/>
        </p:nvSpPr>
        <p:spPr>
          <a:xfrm>
            <a:off x="8091714" y="4440410"/>
            <a:ext cx="2803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Rubisco/</a:t>
            </a:r>
            <a:r>
              <a:rPr lang="en-US" altLang="zh-CN" sz="2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wo duplicat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E23A91E-27CE-537A-C956-EB277E877F1C}"/>
              </a:ext>
            </a:extLst>
          </p:cNvPr>
          <p:cNvSpPr txBox="1"/>
          <p:nvPr/>
        </p:nvSpPr>
        <p:spPr>
          <a:xfrm>
            <a:off x="2617532" y="6239314"/>
            <a:ext cx="34905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 of Fig. 6F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25103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9A4ACE3-4AEC-BFF5-4E36-ABB408EFDC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6968" y="973721"/>
            <a:ext cx="4401184" cy="244160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241F2DD-46E2-6F90-ED6D-AFABEBF15F8A}"/>
              </a:ext>
            </a:extLst>
          </p:cNvPr>
          <p:cNvSpPr txBox="1"/>
          <p:nvPr/>
        </p:nvSpPr>
        <p:spPr>
          <a:xfrm>
            <a:off x="3657600" y="1249680"/>
            <a:ext cx="12394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F1CDB4C-CC20-8D28-52AC-7BE86508FBE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7" t="45820" r="26778" b="36392"/>
          <a:stretch/>
        </p:blipFill>
        <p:spPr>
          <a:xfrm>
            <a:off x="5860507" y="1554236"/>
            <a:ext cx="4396554" cy="100753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9B338F2-90CC-41ED-D9F4-9F602CE80867}"/>
              </a:ext>
            </a:extLst>
          </p:cNvPr>
          <p:cNvSpPr txBox="1"/>
          <p:nvPr/>
        </p:nvSpPr>
        <p:spPr>
          <a:xfrm>
            <a:off x="6640286" y="1249680"/>
            <a:ext cx="12827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Actin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68956529-FC07-D5F4-CCC4-CB68A64A921B}"/>
              </a:ext>
            </a:extLst>
          </p:cNvPr>
          <p:cNvSpPr/>
          <p:nvPr/>
        </p:nvSpPr>
        <p:spPr>
          <a:xfrm>
            <a:off x="3486177" y="907746"/>
            <a:ext cx="1582057" cy="231502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47630F65-197C-20A5-56B9-82BDA96ADE60}"/>
              </a:ext>
            </a:extLst>
          </p:cNvPr>
          <p:cNvSpPr/>
          <p:nvPr/>
        </p:nvSpPr>
        <p:spPr>
          <a:xfrm>
            <a:off x="6170368" y="900489"/>
            <a:ext cx="1628852" cy="231502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804C4EC-6228-2D23-015D-B29F09AA726A}"/>
              </a:ext>
            </a:extLst>
          </p:cNvPr>
          <p:cNvSpPr txBox="1"/>
          <p:nvPr/>
        </p:nvSpPr>
        <p:spPr>
          <a:xfrm>
            <a:off x="2730146" y="6279655"/>
            <a:ext cx="34772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 of Fig. 8D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8C07CD3-F4F7-FA24-1A70-5C4F55A662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403" y="3938433"/>
            <a:ext cx="1965078" cy="230236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DEA8524B-1018-12E6-4435-311D93D4CC92}"/>
              </a:ext>
            </a:extLst>
          </p:cNvPr>
          <p:cNvSpPr txBox="1"/>
          <p:nvPr/>
        </p:nvSpPr>
        <p:spPr>
          <a:xfrm>
            <a:off x="1447423" y="4018916"/>
            <a:ext cx="12827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MYC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5DCB0B9B-3833-9B20-CE75-4D0F10BF658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6177" y="3920571"/>
            <a:ext cx="2082127" cy="2253953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62010932-F9E0-D8DA-63E1-2DC94A50457A}"/>
              </a:ext>
            </a:extLst>
          </p:cNvPr>
          <p:cNvSpPr txBox="1"/>
          <p:nvPr/>
        </p:nvSpPr>
        <p:spPr>
          <a:xfrm>
            <a:off x="4007394" y="4054771"/>
            <a:ext cx="13821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ti-FLAG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E0ABAEE1-B800-FCCD-2A36-2DF592E89C08}"/>
              </a:ext>
            </a:extLst>
          </p:cNvPr>
          <p:cNvSpPr/>
          <p:nvPr/>
        </p:nvSpPr>
        <p:spPr>
          <a:xfrm>
            <a:off x="3418840" y="4419026"/>
            <a:ext cx="2189480" cy="50349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AFDA7D90-04AB-0FE1-0D44-975FA2CC9F22}"/>
              </a:ext>
            </a:extLst>
          </p:cNvPr>
          <p:cNvSpPr/>
          <p:nvPr/>
        </p:nvSpPr>
        <p:spPr>
          <a:xfrm>
            <a:off x="1361440" y="3931920"/>
            <a:ext cx="1475386" cy="23023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03904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5ED6C2C-E01A-1696-7115-2655E2BD9A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68" t="4926" r="4395" b="3633"/>
          <a:stretch/>
        </p:blipFill>
        <p:spPr>
          <a:xfrm>
            <a:off x="1908629" y="316544"/>
            <a:ext cx="7823200" cy="622491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C95324C8-61BF-49B2-ABEF-A1BB8DDB040A}"/>
              </a:ext>
            </a:extLst>
          </p:cNvPr>
          <p:cNvSpPr/>
          <p:nvPr/>
        </p:nvSpPr>
        <p:spPr>
          <a:xfrm>
            <a:off x="2975427" y="1197429"/>
            <a:ext cx="936171" cy="38172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19894601-6265-DDEA-8631-4566D87600FD}"/>
              </a:ext>
            </a:extLst>
          </p:cNvPr>
          <p:cNvSpPr/>
          <p:nvPr/>
        </p:nvSpPr>
        <p:spPr>
          <a:xfrm>
            <a:off x="3917043" y="1197428"/>
            <a:ext cx="936171" cy="38172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BB0B81F-2F15-7961-FC0E-1DA8EF5DA701}"/>
              </a:ext>
            </a:extLst>
          </p:cNvPr>
          <p:cNvSpPr/>
          <p:nvPr/>
        </p:nvSpPr>
        <p:spPr>
          <a:xfrm>
            <a:off x="5842002" y="1190174"/>
            <a:ext cx="936171" cy="38172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328E9D09-C6E3-1C6D-DE12-EE683B9A8F05}"/>
              </a:ext>
            </a:extLst>
          </p:cNvPr>
          <p:cNvSpPr/>
          <p:nvPr/>
        </p:nvSpPr>
        <p:spPr>
          <a:xfrm>
            <a:off x="4880431" y="1204688"/>
            <a:ext cx="936171" cy="38172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DC08B652-8AB6-2C60-CDFF-B2FB8176637B}"/>
              </a:ext>
            </a:extLst>
          </p:cNvPr>
          <p:cNvSpPr/>
          <p:nvPr/>
        </p:nvSpPr>
        <p:spPr>
          <a:xfrm>
            <a:off x="6803573" y="1182916"/>
            <a:ext cx="936171" cy="38172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DC6A8952-6A31-DB70-FEA1-EE45252D5C3F}"/>
              </a:ext>
            </a:extLst>
          </p:cNvPr>
          <p:cNvSpPr/>
          <p:nvPr/>
        </p:nvSpPr>
        <p:spPr>
          <a:xfrm>
            <a:off x="7728859" y="1175653"/>
            <a:ext cx="936171" cy="38172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0611B61-7EE7-56E1-4E5C-34106BD3A1DD}"/>
              </a:ext>
            </a:extLst>
          </p:cNvPr>
          <p:cNvSpPr txBox="1"/>
          <p:nvPr/>
        </p:nvSpPr>
        <p:spPr>
          <a:xfrm>
            <a:off x="6910189" y="1386116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E4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A0A7ECE-DFBC-9A04-FE6E-B3A4D362D0C3}"/>
              </a:ext>
            </a:extLst>
          </p:cNvPr>
          <p:cNvSpPr txBox="1"/>
          <p:nvPr/>
        </p:nvSpPr>
        <p:spPr>
          <a:xfrm>
            <a:off x="3174360" y="1378858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E2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1DFE006-10C1-A2AE-12EC-642644B7EA64}"/>
              </a:ext>
            </a:extLst>
          </p:cNvPr>
          <p:cNvSpPr txBox="1"/>
          <p:nvPr/>
        </p:nvSpPr>
        <p:spPr>
          <a:xfrm>
            <a:off x="7898974" y="1386116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E5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806BF6B-7516-5778-3467-526296F56D6F}"/>
              </a:ext>
            </a:extLst>
          </p:cNvPr>
          <p:cNvSpPr txBox="1"/>
          <p:nvPr/>
        </p:nvSpPr>
        <p:spPr>
          <a:xfrm>
            <a:off x="5002896" y="1378858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E6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F552597-ACB6-4E2E-BE92-B489878F82C5}"/>
              </a:ext>
            </a:extLst>
          </p:cNvPr>
          <p:cNvSpPr txBox="1"/>
          <p:nvPr/>
        </p:nvSpPr>
        <p:spPr>
          <a:xfrm>
            <a:off x="5957511" y="1378858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E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0F522B6-9981-11CB-41C1-4154DC715A78}"/>
              </a:ext>
            </a:extLst>
          </p:cNvPr>
          <p:cNvSpPr txBox="1"/>
          <p:nvPr/>
        </p:nvSpPr>
        <p:spPr>
          <a:xfrm>
            <a:off x="4066908" y="1378858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E3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2CF44A2-74C1-09D0-E4C2-2CE163A317E4}"/>
              </a:ext>
            </a:extLst>
          </p:cNvPr>
          <p:cNvSpPr txBox="1"/>
          <p:nvPr/>
        </p:nvSpPr>
        <p:spPr>
          <a:xfrm>
            <a:off x="2661920" y="6056135"/>
            <a:ext cx="36760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original image of Fig. S15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9728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</TotalTime>
  <Words>115</Words>
  <Application>Microsoft Office PowerPoint</Application>
  <PresentationFormat>宽屏</PresentationFormat>
  <Paragraphs>39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渊忠 姜</dc:creator>
  <cp:lastModifiedBy>渊忠 姜</cp:lastModifiedBy>
  <cp:revision>16</cp:revision>
  <dcterms:created xsi:type="dcterms:W3CDTF">2022-06-21T14:40:13Z</dcterms:created>
  <dcterms:modified xsi:type="dcterms:W3CDTF">2022-06-22T10:45:31Z</dcterms:modified>
</cp:coreProperties>
</file>